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5" r:id="rId2"/>
  </p:sldIdLst>
  <p:sldSz cx="6116638" cy="5121275"/>
  <p:notesSz cx="6858000" cy="9144000"/>
  <p:defaultTextStyle>
    <a:defPPr>
      <a:defRPr lang="en-US"/>
    </a:defPPr>
    <a:lvl1pPr marL="0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799" userDrawn="1">
          <p15:clr>
            <a:srgbClr val="A4A3A4"/>
          </p15:clr>
        </p15:guide>
        <p15:guide id="2" pos="2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FA00"/>
    <a:srgbClr val="1B4DC0"/>
    <a:srgbClr val="D447D9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94" autoAdjust="0"/>
    <p:restoredTop sz="95220"/>
  </p:normalViewPr>
  <p:slideViewPr>
    <p:cSldViewPr snapToGrid="0" snapToObjects="1" showGuides="1">
      <p:cViewPr varScale="1">
        <p:scale>
          <a:sx n="91" d="100"/>
          <a:sy n="91" d="100"/>
        </p:scale>
        <p:origin x="-1746" y="-102"/>
      </p:cViewPr>
      <p:guideLst>
        <p:guide orient="horz" pos="1799"/>
        <p:guide pos="2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0B0F96-8563-CF4A-969C-34502BCA78C4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82713" y="685800"/>
            <a:ext cx="40925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C942F3-F197-D94C-96E7-3A9D04780C8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0538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82713" y="685800"/>
            <a:ext cx="40925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C942F3-F197-D94C-96E7-3A9D04780C8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81966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1590915"/>
            <a:ext cx="5199142" cy="109775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8" y="2902056"/>
            <a:ext cx="4281647" cy="130877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7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205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41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7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411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4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8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548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6417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25924" y="296371"/>
            <a:ext cx="1032183" cy="63114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9375" y="296371"/>
            <a:ext cx="2994604" cy="63114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96285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5224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3" y="3290894"/>
            <a:ext cx="5199142" cy="1017142"/>
          </a:xfrm>
        </p:spPr>
        <p:txBody>
          <a:bodyPr anchor="t"/>
          <a:lstStyle>
            <a:lvl1pPr algn="l">
              <a:defRPr sz="326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3" y="2170615"/>
            <a:ext cx="5199142" cy="1120279"/>
          </a:xfrm>
        </p:spPr>
        <p:txBody>
          <a:bodyPr anchor="b"/>
          <a:lstStyle>
            <a:lvl1pPr marL="0" indent="0">
              <a:buNone/>
              <a:defRPr sz="1634">
                <a:solidFill>
                  <a:schemeClr val="tx1">
                    <a:tint val="75000"/>
                  </a:schemeClr>
                </a:solidFill>
              </a:defRPr>
            </a:lvl1pPr>
            <a:lvl2pPr marL="373532" indent="0">
              <a:buNone/>
              <a:defRPr sz="1471">
                <a:solidFill>
                  <a:schemeClr val="tx1">
                    <a:tint val="75000"/>
                  </a:schemeClr>
                </a:solidFill>
              </a:defRPr>
            </a:lvl2pPr>
            <a:lvl3pPr marL="747065" indent="0">
              <a:buNone/>
              <a:defRPr sz="1307">
                <a:solidFill>
                  <a:schemeClr val="tx1">
                    <a:tint val="75000"/>
                  </a:schemeClr>
                </a:solidFill>
              </a:defRPr>
            </a:lvl3pPr>
            <a:lvl4pPr marL="112059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4pPr>
            <a:lvl5pPr marL="1494130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5pPr>
            <a:lvl6pPr marL="1867662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6pPr>
            <a:lvl7pPr marL="2241194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7pPr>
            <a:lvl8pPr marL="261472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8pPr>
            <a:lvl9pPr marL="2988259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0455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9377" y="1726060"/>
            <a:ext cx="2013393" cy="4881808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44713" y="1726060"/>
            <a:ext cx="2013393" cy="4881808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59771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205089"/>
            <a:ext cx="5504974" cy="853546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3" y="1146360"/>
            <a:ext cx="2702577" cy="477748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3" y="1624108"/>
            <a:ext cx="2702577" cy="2950661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70" y="1146360"/>
            <a:ext cx="2703639" cy="477748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70" y="1624108"/>
            <a:ext cx="2703639" cy="2950661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6351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7690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3193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203902"/>
            <a:ext cx="2012332" cy="867772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8" y="203903"/>
            <a:ext cx="3419371" cy="4370867"/>
          </a:xfrm>
        </p:spPr>
        <p:txBody>
          <a:bodyPr/>
          <a:lstStyle>
            <a:lvl1pPr>
              <a:defRPr sz="2614"/>
            </a:lvl1pPr>
            <a:lvl2pPr>
              <a:defRPr sz="2288"/>
            </a:lvl2pPr>
            <a:lvl3pPr>
              <a:defRPr sz="1961"/>
            </a:lvl3pPr>
            <a:lvl4pPr>
              <a:defRPr sz="1634"/>
            </a:lvl4pPr>
            <a:lvl5pPr>
              <a:defRPr sz="1634"/>
            </a:lvl5pPr>
            <a:lvl6pPr>
              <a:defRPr sz="1634"/>
            </a:lvl6pPr>
            <a:lvl7pPr>
              <a:defRPr sz="1634"/>
            </a:lvl7pPr>
            <a:lvl8pPr>
              <a:defRPr sz="1634"/>
            </a:lvl8pPr>
            <a:lvl9pPr>
              <a:defRPr sz="16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1071674"/>
            <a:ext cx="2012332" cy="3503095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067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6" y="3584892"/>
            <a:ext cx="3669983" cy="423217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6" y="457596"/>
            <a:ext cx="3669983" cy="3072765"/>
          </a:xfrm>
        </p:spPr>
        <p:txBody>
          <a:bodyPr/>
          <a:lstStyle>
            <a:lvl1pPr marL="0" indent="0">
              <a:buNone/>
              <a:defRPr sz="2614"/>
            </a:lvl1pPr>
            <a:lvl2pPr marL="373532" indent="0">
              <a:buNone/>
              <a:defRPr sz="2288"/>
            </a:lvl2pPr>
            <a:lvl3pPr marL="747065" indent="0">
              <a:buNone/>
              <a:defRPr sz="1961"/>
            </a:lvl3pPr>
            <a:lvl4pPr marL="1120597" indent="0">
              <a:buNone/>
              <a:defRPr sz="1634"/>
            </a:lvl4pPr>
            <a:lvl5pPr marL="1494130" indent="0">
              <a:buNone/>
              <a:defRPr sz="1634"/>
            </a:lvl5pPr>
            <a:lvl6pPr marL="1867662" indent="0">
              <a:buNone/>
              <a:defRPr sz="1634"/>
            </a:lvl6pPr>
            <a:lvl7pPr marL="2241194" indent="0">
              <a:buNone/>
              <a:defRPr sz="1634"/>
            </a:lvl7pPr>
            <a:lvl8pPr marL="2614727" indent="0">
              <a:buNone/>
              <a:defRPr sz="1634"/>
            </a:lvl8pPr>
            <a:lvl9pPr marL="2988259" indent="0">
              <a:buNone/>
              <a:defRPr sz="163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6" y="4008110"/>
            <a:ext cx="3669983" cy="601038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84099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205089"/>
            <a:ext cx="5504974" cy="8535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194965"/>
            <a:ext cx="5504974" cy="33798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4746664"/>
            <a:ext cx="1427216" cy="2726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E6976-92C0-DB4E-A75F-8322C56F2F85}" type="datetimeFigureOut">
              <a:rPr lang="en-US" smtClean="0"/>
              <a:pPr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4" y="4746664"/>
            <a:ext cx="1936935" cy="2726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4746664"/>
            <a:ext cx="1427216" cy="2726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87BA5-30B1-2C48-A941-2FCF099E0C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5819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3532" rtl="0" eaLnBrk="1" latinLnBrk="0" hangingPunct="1">
        <a:spcBef>
          <a:spcPct val="0"/>
        </a:spcBef>
        <a:buNone/>
        <a:defRPr sz="35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149" indent="-280149" algn="l" defTabSz="373532" rtl="0" eaLnBrk="1" latinLnBrk="0" hangingPunct="1">
        <a:spcBef>
          <a:spcPct val="20000"/>
        </a:spcBef>
        <a:buFont typeface="Arial"/>
        <a:buChar char="•"/>
        <a:defRPr sz="2614" kern="1200">
          <a:solidFill>
            <a:schemeClr val="tx1"/>
          </a:solidFill>
          <a:latin typeface="+mn-lt"/>
          <a:ea typeface="+mn-ea"/>
          <a:cs typeface="+mn-cs"/>
        </a:defRPr>
      </a:lvl1pPr>
      <a:lvl2pPr marL="606990" indent="-233458" algn="l" defTabSz="373532" rtl="0" eaLnBrk="1" latinLnBrk="0" hangingPunct="1">
        <a:spcBef>
          <a:spcPct val="20000"/>
        </a:spcBef>
        <a:buFont typeface="Arial"/>
        <a:buChar char="–"/>
        <a:defRPr sz="2288" kern="1200">
          <a:solidFill>
            <a:schemeClr val="tx1"/>
          </a:solidFill>
          <a:latin typeface="+mn-lt"/>
          <a:ea typeface="+mn-ea"/>
          <a:cs typeface="+mn-cs"/>
        </a:defRPr>
      </a:lvl2pPr>
      <a:lvl3pPr marL="933831" indent="-186766" algn="l" defTabSz="373532" rtl="0" eaLnBrk="1" latinLnBrk="0" hangingPunct="1">
        <a:spcBef>
          <a:spcPct val="20000"/>
        </a:spcBef>
        <a:buFont typeface="Arial"/>
        <a:buChar char="•"/>
        <a:defRPr sz="1961" kern="1200">
          <a:solidFill>
            <a:schemeClr val="tx1"/>
          </a:solidFill>
          <a:latin typeface="+mn-lt"/>
          <a:ea typeface="+mn-ea"/>
          <a:cs typeface="+mn-cs"/>
        </a:defRPr>
      </a:lvl3pPr>
      <a:lvl4pPr marL="1307363" indent="-186766" algn="l" defTabSz="373532" rtl="0" eaLnBrk="1" latinLnBrk="0" hangingPunct="1">
        <a:spcBef>
          <a:spcPct val="20000"/>
        </a:spcBef>
        <a:buFont typeface="Arial"/>
        <a:buChar char="–"/>
        <a:defRPr sz="1634" kern="1200">
          <a:solidFill>
            <a:schemeClr val="tx1"/>
          </a:solidFill>
          <a:latin typeface="+mn-lt"/>
          <a:ea typeface="+mn-ea"/>
          <a:cs typeface="+mn-cs"/>
        </a:defRPr>
      </a:lvl4pPr>
      <a:lvl5pPr marL="1680896" indent="-186766" algn="l" defTabSz="373532" rtl="0" eaLnBrk="1" latinLnBrk="0" hangingPunct="1">
        <a:spcBef>
          <a:spcPct val="20000"/>
        </a:spcBef>
        <a:buFont typeface="Arial"/>
        <a:buChar char="»"/>
        <a:defRPr sz="1634" kern="1200">
          <a:solidFill>
            <a:schemeClr val="tx1"/>
          </a:solidFill>
          <a:latin typeface="+mn-lt"/>
          <a:ea typeface="+mn-ea"/>
          <a:cs typeface="+mn-cs"/>
        </a:defRPr>
      </a:lvl5pPr>
      <a:lvl6pPr marL="2054428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6pPr>
      <a:lvl7pPr marL="2427961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7pPr>
      <a:lvl8pPr marL="2801493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8pPr>
      <a:lvl9pPr marL="3175025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1pPr>
      <a:lvl2pPr marL="37353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2pPr>
      <a:lvl3pPr marL="747065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3pPr>
      <a:lvl4pPr marL="112059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4pPr>
      <a:lvl5pPr marL="149413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5pPr>
      <a:lvl6pPr marL="186766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6pPr>
      <a:lvl7pPr marL="2241194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7pPr>
      <a:lvl8pPr marL="261472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8pPr>
      <a:lvl9pPr marL="2988259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6531" y="144762"/>
            <a:ext cx="1673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dditional </a:t>
            </a:r>
            <a:r>
              <a:rPr lang="en-US" sz="1000" b="1" smtClean="0"/>
              <a:t>file </a:t>
            </a:r>
            <a:r>
              <a:rPr lang="en-US" sz="1000" b="1" smtClean="0"/>
              <a:t>5: </a:t>
            </a:r>
            <a:r>
              <a:rPr lang="en-US" sz="1000" b="1" smtClean="0">
                <a:ea typeface="Arial" charset="0"/>
                <a:cs typeface="Arial" charset="0"/>
              </a:rPr>
              <a:t> </a:t>
            </a:r>
            <a:r>
              <a:rPr lang="en-US" sz="1000" b="1" dirty="0">
                <a:ea typeface="Arial" charset="0"/>
                <a:cs typeface="Arial" charset="0"/>
              </a:rPr>
              <a:t>Figure S5. </a:t>
            </a: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431952" y="840055"/>
            <a:ext cx="1708643" cy="1538929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975733" y="836844"/>
            <a:ext cx="1708644" cy="1538929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206531" y="434379"/>
            <a:ext cx="41745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ea typeface="Arial" charset="0"/>
                <a:cs typeface="Arial" charset="0"/>
              </a:rPr>
              <a:t>A. Anti-Gal IgG and IgM titers in non-immunized vs. PKH immunized </a:t>
            </a:r>
            <a:r>
              <a:rPr lang="el-GR" sz="900" b="1" dirty="0">
                <a:cs typeface="Arial"/>
              </a:rPr>
              <a:t>α</a:t>
            </a:r>
            <a:r>
              <a:rPr lang="en-GB" sz="900" b="1" dirty="0">
                <a:cs typeface="Arial"/>
              </a:rPr>
              <a:t>1,3GT</a:t>
            </a:r>
            <a:r>
              <a:rPr lang="en-GB" sz="900" b="1" baseline="30000" dirty="0">
                <a:cs typeface="Arial"/>
              </a:rPr>
              <a:t>-/-</a:t>
            </a:r>
            <a:r>
              <a:rPr lang="en-US" sz="900" b="1" dirty="0">
                <a:cs typeface="Arial"/>
              </a:rPr>
              <a:t> mice</a:t>
            </a:r>
            <a:r>
              <a:rPr lang="en-US" sz="900" b="1" dirty="0">
                <a:ea typeface="Arial" charset="0"/>
                <a:cs typeface="Arial" charset="0"/>
              </a:rPr>
              <a:t> 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2975733" y="2961776"/>
            <a:ext cx="1610497" cy="1718222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2753527" y="2681320"/>
            <a:ext cx="21194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C. Efficacy of optimal anti-PD-1 regimen 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06531" y="2683412"/>
            <a:ext cx="15151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B. Dose-titration of AGI-134</a:t>
            </a:r>
          </a:p>
        </p:txBody>
      </p:sp>
      <p:pic>
        <p:nvPicPr>
          <p:cNvPr id="46" name="Picture 45" descr="KW10_Titration_.tiff"/>
          <p:cNvPicPr>
            <a:picLocks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tretch>
            <a:fillRect/>
          </a:stretch>
        </p:blipFill>
        <p:spPr>
          <a:xfrm>
            <a:off x="431952" y="2961779"/>
            <a:ext cx="1916306" cy="2009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992142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49</TotalTime>
  <Words>37</Words>
  <Application>Microsoft Office PowerPoint</Application>
  <PresentationFormat>Custom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cha Kristian</dc:creator>
  <cp:lastModifiedBy>0013358</cp:lastModifiedBy>
  <cp:revision>482</cp:revision>
  <cp:lastPrinted>2017-01-31T00:30:05Z</cp:lastPrinted>
  <dcterms:created xsi:type="dcterms:W3CDTF">2015-08-31T16:55:31Z</dcterms:created>
  <dcterms:modified xsi:type="dcterms:W3CDTF">2019-12-09T12:39:23Z</dcterms:modified>
</cp:coreProperties>
</file>